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C560A-5761-4F16-8932-9B8C26C861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92CD6-8225-4AD4-823B-C0C1D26CFD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E21C7-11CF-472A-A86D-281E42D93E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AA34D3-6CE0-4BF3-A2F8-5E1F290922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4D3B6B-350B-4DA7-AA8F-E373C4EEA2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DE50D-70D5-4716-BE2D-D1B2EDCF88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3DA92-39E0-4E9E-B3AD-E2CD0ADA5F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225CB-C899-49BC-BFCA-32B1B803EB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C2D16-6B55-4E51-89A9-923F959564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B3D00-44EE-4B26-802C-9F22CEDB40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71A425-2B87-4E72-997D-36FBB635C4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891C5-453C-45A3-972C-F5B48B1C41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0A9D9A-B9E6-4C59-BE64-09F39371D1A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692520" y="3443400"/>
            <a:ext cx="2340000" cy="1709640"/>
            <a:chOff x="3692520" y="3443400"/>
            <a:chExt cx="2340000" cy="1709640"/>
          </a:xfrm>
        </p:grpSpPr>
        <p:sp>
          <p:nvSpPr>
            <p:cNvPr id="42" name=""/>
            <p:cNvSpPr/>
            <p:nvPr/>
          </p:nvSpPr>
          <p:spPr>
            <a:xfrm>
              <a:off x="3692520" y="3443400"/>
              <a:ext cx="234000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flipV="1">
              <a:off x="3926520" y="3642840"/>
              <a:ext cx="1440" cy="109188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021200" y="4353840"/>
              <a:ext cx="125640" cy="380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024440" y="4357080"/>
              <a:ext cx="119160" cy="3747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335480" y="4010760"/>
              <a:ext cx="127080" cy="72432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338720" y="4013640"/>
              <a:ext cx="120600" cy="7178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651560" y="4234320"/>
              <a:ext cx="125640" cy="500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654800" y="4237560"/>
              <a:ext cx="119160" cy="4942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966200" y="4156920"/>
              <a:ext cx="125640" cy="577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969440" y="4160160"/>
              <a:ext cx="119160" cy="5713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280480" y="4139640"/>
              <a:ext cx="124200" cy="595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283720" y="4142880"/>
              <a:ext cx="117720" cy="5889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595120" y="4281480"/>
              <a:ext cx="125640" cy="453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598360" y="4284720"/>
              <a:ext cx="119160" cy="4471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4083840" y="4248720"/>
              <a:ext cx="1440" cy="105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063680" y="4248720"/>
              <a:ext cx="406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4398480" y="3773880"/>
              <a:ext cx="1440" cy="236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377960" y="3774240"/>
              <a:ext cx="406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4712760" y="3984840"/>
              <a:ext cx="1440" cy="248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694040" y="3985200"/>
              <a:ext cx="392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5027400" y="3858840"/>
              <a:ext cx="1440" cy="297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008680" y="3859200"/>
              <a:ext cx="392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5342040" y="4114080"/>
              <a:ext cx="144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322960" y="411444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5657760" y="3975840"/>
              <a:ext cx="1440" cy="305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639400" y="3975840"/>
              <a:ext cx="388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926520" y="3643200"/>
              <a:ext cx="1440" cy="1091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912840" y="4735080"/>
              <a:ext cx="136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912840" y="4552560"/>
              <a:ext cx="136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912840" y="4372920"/>
              <a:ext cx="136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912840" y="4190040"/>
              <a:ext cx="136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912840" y="4006080"/>
              <a:ext cx="136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912840" y="3826080"/>
              <a:ext cx="136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912840" y="3643200"/>
              <a:ext cx="136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926520" y="4735080"/>
              <a:ext cx="188244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3926520" y="473472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4241160" y="473472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4557600" y="47347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4871880" y="47347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5186520" y="47347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5501160" y="47347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5815080" y="473472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748760" y="349344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Timp 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831840" y="46864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790800" y="4503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831840" y="4323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790800" y="41396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831840" y="39571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790800" y="3777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831840" y="35946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5400000">
              <a:off x="3999600" y="486252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rot="5400000">
              <a:off x="3979080" y="482796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5400000">
              <a:off x="4314600" y="4898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rot="5400000">
              <a:off x="4246200" y="490104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5400000">
              <a:off x="4266360" y="482544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5400000">
              <a:off x="4629240" y="4898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5400000">
              <a:off x="4561200" y="490104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rot="5400000">
              <a:off x="4572720" y="48340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rot="5400000">
              <a:off x="4933440" y="491076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5400000">
              <a:off x="4875480" y="490104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5400000">
              <a:off x="4879800" y="483876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5400000">
              <a:off x="5258520" y="4898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5400000">
              <a:off x="5191560" y="490104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5400000">
              <a:off x="5153760" y="488232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5400000">
              <a:off x="5572800" y="4898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5400000">
              <a:off x="5553720" y="485568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5400000">
              <a:off x="5490000" y="485604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16200000">
              <a:off x="3593880" y="414396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0" name=""/>
          <p:cNvGrpSpPr/>
          <p:nvPr/>
        </p:nvGrpSpPr>
        <p:grpSpPr>
          <a:xfrm>
            <a:off x="873000" y="5348160"/>
            <a:ext cx="2341440" cy="1710000"/>
            <a:chOff x="873000" y="5348160"/>
            <a:chExt cx="2341440" cy="1710000"/>
          </a:xfrm>
        </p:grpSpPr>
        <p:sp>
          <p:nvSpPr>
            <p:cNvPr id="111" name=""/>
            <p:cNvSpPr/>
            <p:nvPr/>
          </p:nvSpPr>
          <p:spPr>
            <a:xfrm>
              <a:off x="879120" y="5348160"/>
              <a:ext cx="2335320" cy="17100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1225080" y="5571000"/>
              <a:ext cx="1800" cy="108036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317600" y="6464520"/>
              <a:ext cx="124200" cy="18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320840" y="6467760"/>
              <a:ext cx="117720" cy="1807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628280" y="5760720"/>
              <a:ext cx="124200" cy="891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631520" y="5763600"/>
              <a:ext cx="117720" cy="8848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939320" y="5963400"/>
              <a:ext cx="122400" cy="688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942560" y="5966640"/>
              <a:ext cx="116280" cy="6818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248200" y="5968440"/>
              <a:ext cx="124200" cy="68328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251440" y="5971680"/>
              <a:ext cx="117720" cy="67680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2559240" y="5883480"/>
              <a:ext cx="124200" cy="7682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562480" y="5886360"/>
              <a:ext cx="117720" cy="7621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870280" y="6376320"/>
              <a:ext cx="124200" cy="275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873520" y="6379560"/>
              <a:ext cx="117720" cy="268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1379520" y="6422040"/>
              <a:ext cx="1440" cy="42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359000" y="6422040"/>
              <a:ext cx="410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1690560" y="5649120"/>
              <a:ext cx="1440" cy="111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1670040" y="5649120"/>
              <a:ext cx="410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2001600" y="5675400"/>
              <a:ext cx="1440" cy="287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1980720" y="5675760"/>
              <a:ext cx="410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V="1">
              <a:off x="2309040" y="5751000"/>
              <a:ext cx="1440" cy="217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289960" y="5751000"/>
              <a:ext cx="414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2620080" y="5711400"/>
              <a:ext cx="1440" cy="171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600640" y="5711760"/>
              <a:ext cx="4140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2930760" y="6339600"/>
              <a:ext cx="1440" cy="36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911680" y="633996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225080" y="5571360"/>
              <a:ext cx="1800" cy="1080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210680" y="6652080"/>
              <a:ext cx="140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210680" y="6530760"/>
              <a:ext cx="140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210680" y="641232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210680" y="6291360"/>
              <a:ext cx="140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210680" y="617004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210680" y="605160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210680" y="5930640"/>
              <a:ext cx="140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210680" y="5811120"/>
              <a:ext cx="140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210680" y="5691600"/>
              <a:ext cx="140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210680" y="557136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225080" y="6652080"/>
              <a:ext cx="1857240" cy="432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1225080" y="665172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1535760" y="665172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flipV="1">
              <a:off x="1846800" y="665172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2156040" y="665172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2466720" y="665172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2777400" y="665172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3088440" y="665172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985040" y="539532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Timp 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082880" y="6604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999000" y="64836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971640" y="636372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971640" y="624384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971640" y="612288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0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971640" y="600480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971640" y="588348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0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971640" y="576216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971640" y="564408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0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971640" y="552312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5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rot="5400000">
              <a:off x="1295280" y="677880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rot="5400000">
              <a:off x="1271880" y="674280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rot="5400000">
              <a:off x="1606680" y="68137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rot="5400000">
              <a:off x="1537560" y="68173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rot="5400000">
              <a:off x="1555560" y="673848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rot="5400000">
              <a:off x="1916280" y="68137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rot="5400000">
              <a:off x="1846800" y="68173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rot="5400000">
              <a:off x="1856520" y="674892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rot="5400000">
              <a:off x="2216520" y="682380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rot="5400000">
              <a:off x="2157840" y="68173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rot="5400000">
              <a:off x="2160000" y="675360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rot="5400000">
              <a:off x="2538000" y="68137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rot="5400000">
              <a:off x="2468880" y="68173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5400000">
              <a:off x="2429280" y="679572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rot="5400000">
              <a:off x="2848680" y="68137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rot="5400000">
              <a:off x="2827080" y="677016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rot="5400000">
              <a:off x="2762280" y="677124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rot="16200000">
              <a:off x="753840" y="605628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5" name=""/>
          <p:cNvGrpSpPr/>
          <p:nvPr/>
        </p:nvGrpSpPr>
        <p:grpSpPr>
          <a:xfrm>
            <a:off x="3692520" y="5348160"/>
            <a:ext cx="2340000" cy="1710000"/>
            <a:chOff x="3692520" y="5348160"/>
            <a:chExt cx="2340000" cy="1710000"/>
          </a:xfrm>
        </p:grpSpPr>
        <p:sp>
          <p:nvSpPr>
            <p:cNvPr id="186" name=""/>
            <p:cNvSpPr/>
            <p:nvPr/>
          </p:nvSpPr>
          <p:spPr>
            <a:xfrm>
              <a:off x="3692520" y="5348160"/>
              <a:ext cx="2340000" cy="17100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 flipV="1">
              <a:off x="3953520" y="5551200"/>
              <a:ext cx="1440" cy="107892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046400" y="5887440"/>
              <a:ext cx="125280" cy="742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049280" y="5890680"/>
              <a:ext cx="119160" cy="7365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357800" y="5813280"/>
              <a:ext cx="123840" cy="816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360680" y="5816520"/>
              <a:ext cx="117720" cy="8103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4669200" y="6073560"/>
              <a:ext cx="125640" cy="556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4672440" y="6076800"/>
              <a:ext cx="119160" cy="5504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980240" y="6029640"/>
              <a:ext cx="123840" cy="6008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4983480" y="6032520"/>
              <a:ext cx="117360" cy="5943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5291640" y="5939640"/>
              <a:ext cx="125640" cy="690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5294880" y="5942520"/>
              <a:ext cx="119160" cy="6843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603040" y="6160320"/>
              <a:ext cx="124200" cy="46980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606280" y="6163560"/>
              <a:ext cx="117720" cy="4633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flipV="1">
              <a:off x="4107600" y="5716800"/>
              <a:ext cx="1440" cy="17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4088880" y="571716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4420440" y="5723280"/>
              <a:ext cx="1080" cy="89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4400280" y="572364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4730400" y="5827680"/>
              <a:ext cx="1080" cy="245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711680" y="582768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5041800" y="5832000"/>
              <a:ext cx="1080" cy="196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5021280" y="5832360"/>
              <a:ext cx="403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5353200" y="5893560"/>
              <a:ext cx="1080" cy="45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334120" y="5893920"/>
              <a:ext cx="406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V="1">
              <a:off x="5666040" y="6081840"/>
              <a:ext cx="1080" cy="78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680" bIns="31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5645520" y="6081840"/>
              <a:ext cx="406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3953520" y="5551560"/>
              <a:ext cx="1440" cy="1078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3937680" y="663048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3937680" y="645048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3937680" y="62708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3937680" y="60908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3937680" y="591120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3937680" y="573156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3937680" y="555156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3953520" y="6630480"/>
              <a:ext cx="187128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3953520" y="663012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4266360" y="66301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V="1">
              <a:off x="4576320" y="66301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flipV="1">
              <a:off x="4887720" y="66301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5199120" y="66301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5510160" y="66301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V="1">
              <a:off x="5821560" y="66301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4748760" y="539532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Timp 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3863160" y="65800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820320" y="64000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3820320" y="6220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820320" y="6040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820320" y="58608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820320" y="56808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3820320" y="5501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rot="5400000">
              <a:off x="4028760" y="676116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rot="5400000">
              <a:off x="4004640" y="672516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rot="5400000">
              <a:off x="4340160" y="67942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rot="5400000">
              <a:off x="4270320" y="67996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rot="5400000">
              <a:off x="4288680" y="672084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rot="5400000">
              <a:off x="4650840" y="67942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rot="5400000">
              <a:off x="4582800" y="67996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rot="5400000">
              <a:off x="4591800" y="67298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rot="5400000">
              <a:off x="4952520" y="680688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rot="5400000">
              <a:off x="4894200" y="68004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rot="5400000">
              <a:off x="4895280" y="673596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rot="5400000">
              <a:off x="5274000" y="67942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rot="5400000">
              <a:off x="5207040" y="68004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rot="5400000">
              <a:off x="5165640" y="677844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rot="5400000">
              <a:off x="5583960" y="67942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rot="5400000">
              <a:off x="5562720" y="675288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 rot="5400000">
              <a:off x="5499000" y="675324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 rot="16200000">
              <a:off x="3603240" y="604980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254" name=""/>
          <p:cNvGraphicFramePr/>
          <p:nvPr/>
        </p:nvGraphicFramePr>
        <p:xfrm>
          <a:off x="838080" y="3429000"/>
          <a:ext cx="2397240" cy="17668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25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838080" y="3429000"/>
                    <a:ext cx="2397240" cy="1766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256" name=""/>
          <p:cNvGrpSpPr/>
          <p:nvPr/>
        </p:nvGrpSpPr>
        <p:grpSpPr>
          <a:xfrm>
            <a:off x="852480" y="685800"/>
            <a:ext cx="2339640" cy="1709640"/>
            <a:chOff x="852480" y="685800"/>
            <a:chExt cx="2339640" cy="1709640"/>
          </a:xfrm>
        </p:grpSpPr>
        <p:sp>
          <p:nvSpPr>
            <p:cNvPr id="257" name=""/>
            <p:cNvSpPr/>
            <p:nvPr/>
          </p:nvSpPr>
          <p:spPr>
            <a:xfrm>
              <a:off x="852480" y="685800"/>
              <a:ext cx="233964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 flipV="1">
              <a:off x="1085760" y="899280"/>
              <a:ext cx="1800" cy="109260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1181520" y="1220400"/>
              <a:ext cx="131400" cy="772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1184760" y="1223640"/>
              <a:ext cx="124920" cy="7657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1507680" y="1616760"/>
              <a:ext cx="131040" cy="3758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1510920" y="1619640"/>
              <a:ext cx="124560" cy="3693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833480" y="1854000"/>
              <a:ext cx="131040" cy="138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1836720" y="1857240"/>
              <a:ext cx="124920" cy="1317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2159280" y="1788120"/>
              <a:ext cx="131040" cy="204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2162520" y="1791360"/>
              <a:ext cx="124920" cy="197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2485080" y="1602720"/>
              <a:ext cx="129600" cy="389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488680" y="1605960"/>
              <a:ext cx="123120" cy="3834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809440" y="1767960"/>
              <a:ext cx="131040" cy="224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812680" y="1771200"/>
              <a:ext cx="124560" cy="2181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 flipV="1">
              <a:off x="1247760" y="1066320"/>
              <a:ext cx="1800" cy="154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1226880" y="106632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flipV="1">
              <a:off x="1572120" y="1514160"/>
              <a:ext cx="1800" cy="101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551240" y="151452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1898280" y="1783440"/>
              <a:ext cx="1440" cy="7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760" bIns="23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1878840" y="1783440"/>
              <a:ext cx="417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 flipV="1">
              <a:off x="2222640" y="1709280"/>
              <a:ext cx="1440" cy="78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2203200" y="1709640"/>
              <a:ext cx="417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 flipV="1">
              <a:off x="2548440" y="1569600"/>
              <a:ext cx="1440" cy="33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529000" y="1569600"/>
              <a:ext cx="421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flipV="1">
              <a:off x="2874240" y="1718640"/>
              <a:ext cx="1800" cy="48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" bIns="1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854800" y="171900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1085760" y="899640"/>
              <a:ext cx="1800" cy="1092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1069560" y="199260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1069560" y="183708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1069560" y="167976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1069560" y="152388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1069560" y="136836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1069560" y="121104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1069560" y="10551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1069560" y="89964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1085760" y="1992600"/>
              <a:ext cx="194904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 flipV="1">
              <a:off x="1085760" y="199224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 flipV="1">
              <a:off x="1410120" y="199224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 flipV="1">
              <a:off x="1736280" y="199224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 flipV="1">
              <a:off x="2062080" y="199224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 flipV="1">
              <a:off x="2387880" y="199224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 flipV="1">
              <a:off x="2712240" y="199224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 flipV="1">
              <a:off x="3038400" y="199224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1941120" y="73260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2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1004040" y="19440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1004040" y="17881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976320" y="16322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976320" y="14752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976320" y="13194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976320" y="11635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976320" y="10062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976320" y="8506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 rot="5400000">
              <a:off x="1163520" y="211968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 rot="5400000">
              <a:off x="1137600" y="208332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 rot="5400000">
              <a:off x="1490760" y="2153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 rot="5400000">
              <a:off x="1420560" y="21582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 rot="5400000">
              <a:off x="1435680" y="207936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 rot="5400000">
              <a:off x="1816560" y="2153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rot="5400000">
              <a:off x="1746360" y="21582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rot="5400000">
              <a:off x="1751760" y="20894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 rot="5400000">
              <a:off x="2132280" y="216432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 rot="5400000">
              <a:off x="2072160" y="21582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rot="5400000">
              <a:off x="2071440" y="209268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 rot="5400000">
              <a:off x="2468160" y="2153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rot="5400000">
              <a:off x="2398320" y="21582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 rot="5400000">
              <a:off x="2356200" y="213624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 rot="5400000">
              <a:off x="2793960" y="2153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 rot="5400000">
              <a:off x="2771640" y="211104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 rot="5400000">
              <a:off x="2705760" y="211320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 rot="16200000">
              <a:off x="751320" y="139356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7" name=""/>
          <p:cNvGrpSpPr/>
          <p:nvPr/>
        </p:nvGrpSpPr>
        <p:grpSpPr>
          <a:xfrm>
            <a:off x="3809880" y="685800"/>
            <a:ext cx="2339640" cy="1709640"/>
            <a:chOff x="3809880" y="685800"/>
            <a:chExt cx="2339640" cy="1709640"/>
          </a:xfrm>
        </p:grpSpPr>
        <p:sp>
          <p:nvSpPr>
            <p:cNvPr id="328" name=""/>
            <p:cNvSpPr/>
            <p:nvPr/>
          </p:nvSpPr>
          <p:spPr>
            <a:xfrm>
              <a:off x="3809880" y="685800"/>
              <a:ext cx="233964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flipV="1">
              <a:off x="4017600" y="890640"/>
              <a:ext cx="1440" cy="109368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4116600" y="1403640"/>
              <a:ext cx="131400" cy="58068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4119840" y="1406880"/>
              <a:ext cx="124920" cy="57420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4446360" y="1428840"/>
              <a:ext cx="129960" cy="555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4449960" y="1431720"/>
              <a:ext cx="123120" cy="5493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4774680" y="1586160"/>
              <a:ext cx="131400" cy="397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4778280" y="1589040"/>
              <a:ext cx="124920" cy="3916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5104440" y="1436760"/>
              <a:ext cx="129960" cy="547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5108040" y="1440000"/>
              <a:ext cx="123120" cy="5410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5433120" y="1357920"/>
              <a:ext cx="131400" cy="626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5436360" y="1361160"/>
              <a:ext cx="124920" cy="619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5762880" y="1711800"/>
              <a:ext cx="129960" cy="272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5766120" y="1715040"/>
              <a:ext cx="123120" cy="2656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 flipV="1">
              <a:off x="4183200" y="1266480"/>
              <a:ext cx="1440" cy="136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4162320" y="1266480"/>
              <a:ext cx="417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 flipV="1">
              <a:off x="4511520" y="1356120"/>
              <a:ext cx="1440" cy="72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4490280" y="1356480"/>
              <a:ext cx="435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 flipV="1">
              <a:off x="4841640" y="1425600"/>
              <a:ext cx="1440" cy="16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4820040" y="142560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 flipV="1">
              <a:off x="5169960" y="1047600"/>
              <a:ext cx="1440" cy="388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5148360" y="1047600"/>
              <a:ext cx="435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 flipV="1">
              <a:off x="5497920" y="1287000"/>
              <a:ext cx="1800" cy="70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760" bIns="23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5478120" y="128700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 flipV="1">
              <a:off x="5828040" y="1644120"/>
              <a:ext cx="1440" cy="67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5806440" y="1644480"/>
              <a:ext cx="435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4017600" y="890640"/>
              <a:ext cx="1440" cy="10936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4002840" y="1984320"/>
              <a:ext cx="14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4002840" y="1803240"/>
              <a:ext cx="14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4002840" y="162108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4002840" y="1438200"/>
              <a:ext cx="14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4002840" y="1253880"/>
              <a:ext cx="14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4002840" y="107280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4002840" y="89064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4017600" y="1984320"/>
              <a:ext cx="197100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 flipV="1">
              <a:off x="4017600" y="198396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 flipV="1">
              <a:off x="4347360" y="198396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 flipV="1">
              <a:off x="4675680" y="198396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 flipV="1">
              <a:off x="5005440" y="198396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 flipV="1">
              <a:off x="5333760" y="198396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 flipV="1">
              <a:off x="5663520" y="198396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flipV="1">
              <a:off x="5991840" y="198396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4826160" y="73440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2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3948480" y="1937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3948480" y="1754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3948480" y="1573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3948480" y="13910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3948480" y="12067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3948480" y="1024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948480" y="8431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 rot="5400000">
              <a:off x="4103640" y="211464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 rot="5400000">
              <a:off x="4073040" y="207720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 rot="5400000">
              <a:off x="4433040" y="2148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 rot="5400000">
              <a:off x="4359600" y="21502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 rot="5400000">
              <a:off x="4373280" y="207288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rot="5400000">
              <a:off x="4761360" y="2148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 rot="5400000">
              <a:off x="4689720" y="21502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 rot="5400000">
              <a:off x="4693320" y="208332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 rot="5400000">
              <a:off x="5079240" y="215964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 rot="5400000">
              <a:off x="5016240" y="21502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 rot="5400000">
              <a:off x="5018400" y="208800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 rot="5400000">
              <a:off x="5419440" y="2148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 rot="5400000">
              <a:off x="5347440" y="21502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 rot="5400000">
              <a:off x="5303880" y="213156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 rot="5400000">
              <a:off x="5747760" y="2148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 rot="5400000">
              <a:off x="5723280" y="210456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 rot="5400000">
              <a:off x="5655600" y="210528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 rot="16200000">
              <a:off x="3714840" y="138924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6" name=""/>
          <p:cNvSpPr/>
          <p:nvPr/>
        </p:nvSpPr>
        <p:spPr>
          <a:xfrm>
            <a:off x="839880" y="3048120"/>
            <a:ext cx="76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IMP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3T19:27:41Z</dcterms:created>
  <dc:creator>CRUK CRUK</dc:creator>
  <dc:description/>
  <dc:language>en-US</dc:language>
  <cp:lastModifiedBy>CRUK CRUK</cp:lastModifiedBy>
  <dcterms:modified xsi:type="dcterms:W3CDTF">2009-01-13T19:30:10Z</dcterms:modified>
  <cp:revision>3</cp:revision>
  <dc:subject/>
  <dc:title>PowerPoint Presentation</dc:title>
</cp:coreProperties>
</file>